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25222"/>
    <a:srgbClr val="85312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457200" y="228600"/>
            <a:ext cx="8382000" cy="6390620"/>
            <a:chOff x="457200" y="228600"/>
            <a:chExt cx="8382000" cy="6390620"/>
          </a:xfrm>
        </p:grpSpPr>
        <p:grpSp>
          <p:nvGrpSpPr>
            <p:cNvPr id="24" name="Group 23"/>
            <p:cNvGrpSpPr/>
            <p:nvPr/>
          </p:nvGrpSpPr>
          <p:grpSpPr>
            <a:xfrm>
              <a:off x="1795045" y="228600"/>
              <a:ext cx="5443955" cy="5901154"/>
              <a:chOff x="1566445" y="423446"/>
              <a:chExt cx="5443955" cy="5901154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1566445" y="423446"/>
                <a:ext cx="5443955" cy="5901154"/>
                <a:chOff x="1566445" y="685800"/>
                <a:chExt cx="5443955" cy="5901154"/>
              </a:xfrm>
            </p:grpSpPr>
            <p:grpSp>
              <p:nvGrpSpPr>
                <p:cNvPr id="13" name="Group 12"/>
                <p:cNvGrpSpPr/>
                <p:nvPr/>
              </p:nvGrpSpPr>
              <p:grpSpPr>
                <a:xfrm>
                  <a:off x="1752600" y="685800"/>
                  <a:ext cx="5029200" cy="5347772"/>
                  <a:chOff x="1752600" y="685800"/>
                  <a:chExt cx="5029200" cy="5347772"/>
                </a:xfrm>
              </p:grpSpPr>
              <p:grpSp>
                <p:nvGrpSpPr>
                  <p:cNvPr id="8" name="Group 7"/>
                  <p:cNvGrpSpPr/>
                  <p:nvPr/>
                </p:nvGrpSpPr>
                <p:grpSpPr>
                  <a:xfrm>
                    <a:off x="2286000" y="685800"/>
                    <a:ext cx="4495800" cy="5347772"/>
                    <a:chOff x="2286000" y="685800"/>
                    <a:chExt cx="4495800" cy="5347772"/>
                  </a:xfrm>
                </p:grpSpPr>
                <p:pic>
                  <p:nvPicPr>
                    <p:cNvPr id="1026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2286000" y="685800"/>
                      <a:ext cx="4343400" cy="5347772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  <a:effectLst/>
                  </p:spPr>
                </p:pic>
                <p:sp>
                  <p:nvSpPr>
                    <p:cNvPr id="5" name="TextBox 4"/>
                    <p:cNvSpPr txBox="1"/>
                    <p:nvPr/>
                  </p:nvSpPr>
                  <p:spPr>
                    <a:xfrm>
                      <a:off x="5486400" y="716577"/>
                      <a:ext cx="11430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smtClean="0">
                          <a:latin typeface="Times New Roman" pitchFamily="18" charset="0"/>
                          <a:cs typeface="Times New Roman" pitchFamily="18" charset="0"/>
                        </a:rPr>
                        <a:t>Population 1</a:t>
                      </a:r>
                      <a:endParaRPr lang="en-US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6" name="TextBox 5"/>
                    <p:cNvSpPr txBox="1"/>
                    <p:nvPr/>
                  </p:nvSpPr>
                  <p:spPr>
                    <a:xfrm>
                      <a:off x="5486400" y="1021377"/>
                      <a:ext cx="11430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smtClean="0">
                          <a:latin typeface="Times New Roman" pitchFamily="18" charset="0"/>
                          <a:cs typeface="Times New Roman" pitchFamily="18" charset="0"/>
                        </a:rPr>
                        <a:t>Population 2</a:t>
                      </a:r>
                      <a:endParaRPr lang="en-US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sp>
                  <p:nvSpPr>
                    <p:cNvPr id="7" name="TextBox 6"/>
                    <p:cNvSpPr txBox="1"/>
                    <p:nvPr/>
                  </p:nvSpPr>
                  <p:spPr>
                    <a:xfrm>
                      <a:off x="5486400" y="1252954"/>
                      <a:ext cx="12954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smtClean="0">
                          <a:latin typeface="Times New Roman" pitchFamily="18" charset="0"/>
                          <a:cs typeface="Times New Roman" pitchFamily="18" charset="0"/>
                        </a:rPr>
                        <a:t>Population 3</a:t>
                      </a:r>
                      <a:endParaRPr lang="en-US" sz="1400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</p:grpSp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1752600" y="4876800"/>
                    <a:ext cx="685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Times New Roman" pitchFamily="18" charset="0"/>
                        <a:cs typeface="Times New Roman" pitchFamily="18" charset="0"/>
                      </a:rPr>
                      <a:t>-0.1</a:t>
                    </a:r>
                    <a:endParaRPr lang="en-US" sz="14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1828800" y="3578423"/>
                    <a:ext cx="685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Times New Roman" pitchFamily="18" charset="0"/>
                        <a:cs typeface="Times New Roman" pitchFamily="18" charset="0"/>
                      </a:rPr>
                      <a:t>0.0</a:t>
                    </a:r>
                    <a:endParaRPr lang="en-US" sz="14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1828800" y="2209800"/>
                    <a:ext cx="685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Times New Roman" pitchFamily="18" charset="0"/>
                        <a:cs typeface="Times New Roman" pitchFamily="18" charset="0"/>
                      </a:rPr>
                      <a:t>0.1</a:t>
                    </a:r>
                    <a:endParaRPr lang="en-US" sz="14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1828800" y="914400"/>
                    <a:ext cx="685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 smtClean="0">
                        <a:latin typeface="Times New Roman" pitchFamily="18" charset="0"/>
                        <a:cs typeface="Times New Roman" pitchFamily="18" charset="0"/>
                      </a:rPr>
                      <a:t>0.2</a:t>
                    </a:r>
                    <a:endParaRPr lang="en-US" sz="14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</p:grpSp>
            <p:sp>
              <p:nvSpPr>
                <p:cNvPr id="14" name="TextBox 13"/>
                <p:cNvSpPr txBox="1"/>
                <p:nvPr/>
              </p:nvSpPr>
              <p:spPr>
                <a:xfrm>
                  <a:off x="2667000" y="6016823"/>
                  <a:ext cx="6858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-0.10</a:t>
                  </a:r>
                  <a:endParaRPr lang="en-US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3810000" y="6019800"/>
                  <a:ext cx="6858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-0.08</a:t>
                  </a:r>
                  <a:endParaRPr lang="en-US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5029200" y="6019800"/>
                  <a:ext cx="6858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-0.06</a:t>
                  </a:r>
                  <a:endParaRPr lang="en-US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6324600" y="6019800"/>
                  <a:ext cx="6858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-0.04</a:t>
                  </a:r>
                  <a:endParaRPr lang="en-US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3810000" y="6248400"/>
                  <a:ext cx="14478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itchFamily="18" charset="0"/>
                      <a:cs typeface="Times New Roman" pitchFamily="18" charset="0"/>
                    </a:rPr>
                    <a:t>PC1 (85.65%)</a:t>
                  </a:r>
                  <a:endParaRPr 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6200000">
                  <a:off x="1011822" y="3221622"/>
                  <a:ext cx="14478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itchFamily="18" charset="0"/>
                      <a:cs typeface="Times New Roman" pitchFamily="18" charset="0"/>
                    </a:rPr>
                    <a:t>PC2 (9.3%)</a:t>
                  </a:r>
                  <a:endParaRPr 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21" name="Oval 20"/>
              <p:cNvSpPr/>
              <p:nvPr/>
            </p:nvSpPr>
            <p:spPr>
              <a:xfrm>
                <a:off x="5410200" y="609600"/>
                <a:ext cx="76201" cy="76200"/>
              </a:xfrm>
              <a:prstGeom prst="ellipse">
                <a:avLst/>
              </a:prstGeom>
              <a:solidFill>
                <a:srgbClr val="85312F"/>
              </a:solidFill>
              <a:ln>
                <a:solidFill>
                  <a:srgbClr val="85312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Oval 21"/>
              <p:cNvSpPr/>
              <p:nvPr/>
            </p:nvSpPr>
            <p:spPr>
              <a:xfrm>
                <a:off x="5410200" y="838200"/>
                <a:ext cx="76201" cy="76200"/>
              </a:xfrm>
              <a:prstGeom prst="ellipse">
                <a:avLst/>
              </a:prstGeom>
              <a:solidFill>
                <a:srgbClr val="425222"/>
              </a:solidFill>
              <a:ln>
                <a:solidFill>
                  <a:srgbClr val="42522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Oval 22"/>
              <p:cNvSpPr/>
              <p:nvPr/>
            </p:nvSpPr>
            <p:spPr>
              <a:xfrm>
                <a:off x="5410200" y="1109246"/>
                <a:ext cx="76201" cy="76200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457200" y="6096000"/>
              <a:ext cx="8382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Principal component analysis using 55634 high quality GBS based SNPs assigned to 144 diverse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ungbean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genotypes  into three populations (1, 2 and 3)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54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VI</dc:creator>
  <cp:lastModifiedBy>RAVIR</cp:lastModifiedBy>
  <cp:revision>9</cp:revision>
  <dcterms:created xsi:type="dcterms:W3CDTF">2006-08-16T00:00:00Z</dcterms:created>
  <dcterms:modified xsi:type="dcterms:W3CDTF">2020-02-02T13:34:28Z</dcterms:modified>
</cp:coreProperties>
</file>